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1198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2904" y="114"/>
      </p:cViewPr>
      <p:guideLst>
        <p:guide orient="horz" pos="2495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 dirty="0"/>
              <a:t>VvAPX2</a:t>
            </a:r>
            <a:endParaRPr lang="zh-CN" i="1" dirty="0"/>
          </a:p>
        </c:rich>
      </c:tx>
      <c:layout>
        <c:manualLayout>
          <c:xMode val="edge"/>
          <c:yMode val="edge"/>
          <c:x val="0.43167573151309019"/>
          <c:y val="3.67816180726142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479013695179858"/>
          <c:y val="0.13673455485572078"/>
          <c:w val="0.80957405999432741"/>
          <c:h val="0.746675036946300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VvAPX1!$G$1</c:f>
              <c:strCache>
                <c:ptCount val="1"/>
                <c:pt idx="0">
                  <c:v>Mock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VvAPX1!$H$2:$H$7</c:f>
                <c:numCache>
                  <c:formatCode>General</c:formatCode>
                  <c:ptCount val="6"/>
                  <c:pt idx="0">
                    <c:v>0.189506297923693</c:v>
                  </c:pt>
                  <c:pt idx="1">
                    <c:v>0.31070268391637301</c:v>
                  </c:pt>
                  <c:pt idx="2">
                    <c:v>0.17046225502266399</c:v>
                  </c:pt>
                  <c:pt idx="3">
                    <c:v>9.2361348174715793E-2</c:v>
                  </c:pt>
                  <c:pt idx="4">
                    <c:v>0.162456429482943</c:v>
                  </c:pt>
                  <c:pt idx="5">
                    <c:v>7.0186718013542607E-2</c:v>
                  </c:pt>
                </c:numCache>
              </c:numRef>
            </c:plus>
            <c:minus>
              <c:numRef>
                <c:f>VvAPX1!$H$2:$H$7</c:f>
                <c:numCache>
                  <c:formatCode>General</c:formatCode>
                  <c:ptCount val="6"/>
                  <c:pt idx="0">
                    <c:v>0.189506297923693</c:v>
                  </c:pt>
                  <c:pt idx="1">
                    <c:v>0.31070268391637301</c:v>
                  </c:pt>
                  <c:pt idx="2">
                    <c:v>0.17046225502266399</c:v>
                  </c:pt>
                  <c:pt idx="3">
                    <c:v>9.2361348174715793E-2</c:v>
                  </c:pt>
                  <c:pt idx="4">
                    <c:v>0.162456429482943</c:v>
                  </c:pt>
                  <c:pt idx="5">
                    <c:v>7.018671801354260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VvAPX1!$F$2:$F$7</c:f>
              <c:strCache>
                <c:ptCount val="6"/>
                <c:pt idx="0">
                  <c:v>0</c:v>
                </c:pt>
                <c:pt idx="1">
                  <c:v>12h</c:v>
                </c:pt>
                <c:pt idx="2">
                  <c:v>24h</c:v>
                </c:pt>
                <c:pt idx="3">
                  <c:v>48h</c:v>
                </c:pt>
                <c:pt idx="4">
                  <c:v>72h</c:v>
                </c:pt>
                <c:pt idx="5">
                  <c:v>96h</c:v>
                </c:pt>
              </c:strCache>
            </c:strRef>
          </c:cat>
          <c:val>
            <c:numRef>
              <c:f>VvAPX1!$G$2:$G$7</c:f>
              <c:numCache>
                <c:formatCode>###0.00000;\-###0.00000</c:formatCode>
                <c:ptCount val="6"/>
                <c:pt idx="0">
                  <c:v>1</c:v>
                </c:pt>
                <c:pt idx="1">
                  <c:v>1.6334790554957399</c:v>
                </c:pt>
                <c:pt idx="2">
                  <c:v>1.0957727238036099</c:v>
                </c:pt>
                <c:pt idx="3">
                  <c:v>0.91443847046945703</c:v>
                </c:pt>
                <c:pt idx="4">
                  <c:v>0.93239613318679904</c:v>
                </c:pt>
                <c:pt idx="5">
                  <c:v>0.929877464454793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07F-4843-98E0-F5AE4050AB38}"/>
            </c:ext>
          </c:extLst>
        </c:ser>
        <c:ser>
          <c:idx val="1"/>
          <c:order val="1"/>
          <c:tx>
            <c:strRef>
              <c:f>VvAPX1!$I$1</c:f>
              <c:strCache>
                <c:ptCount val="1"/>
                <c:pt idx="0">
                  <c:v>Pv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VvAPX1!$J$2:$J$7</c:f>
                <c:numCache>
                  <c:formatCode>General</c:formatCode>
                  <c:ptCount val="6"/>
                  <c:pt idx="0">
                    <c:v>0.19550414254493001</c:v>
                  </c:pt>
                  <c:pt idx="1">
                    <c:v>0.47243395312940301</c:v>
                  </c:pt>
                  <c:pt idx="2">
                    <c:v>9.8707114657217598E-2</c:v>
                  </c:pt>
                  <c:pt idx="3">
                    <c:v>0.21074637251880199</c:v>
                  </c:pt>
                  <c:pt idx="4">
                    <c:v>0.31760471354880798</c:v>
                  </c:pt>
                  <c:pt idx="5">
                    <c:v>9.2848553065751196E-2</c:v>
                  </c:pt>
                </c:numCache>
              </c:numRef>
            </c:plus>
            <c:minus>
              <c:numRef>
                <c:f>VvAPX1!$J$2:$J$7</c:f>
                <c:numCache>
                  <c:formatCode>General</c:formatCode>
                  <c:ptCount val="6"/>
                  <c:pt idx="0">
                    <c:v>0.19550414254493001</c:v>
                  </c:pt>
                  <c:pt idx="1">
                    <c:v>0.47243395312940301</c:v>
                  </c:pt>
                  <c:pt idx="2">
                    <c:v>9.8707114657217598E-2</c:v>
                  </c:pt>
                  <c:pt idx="3">
                    <c:v>0.21074637251880199</c:v>
                  </c:pt>
                  <c:pt idx="4">
                    <c:v>0.31760471354880798</c:v>
                  </c:pt>
                  <c:pt idx="5">
                    <c:v>9.284855306575119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VvAPX1!$F$2:$F$7</c:f>
              <c:strCache>
                <c:ptCount val="6"/>
                <c:pt idx="0">
                  <c:v>0</c:v>
                </c:pt>
                <c:pt idx="1">
                  <c:v>12h</c:v>
                </c:pt>
                <c:pt idx="2">
                  <c:v>24h</c:v>
                </c:pt>
                <c:pt idx="3">
                  <c:v>48h</c:v>
                </c:pt>
                <c:pt idx="4">
                  <c:v>72h</c:v>
                </c:pt>
                <c:pt idx="5">
                  <c:v>96h</c:v>
                </c:pt>
              </c:strCache>
            </c:strRef>
          </c:cat>
          <c:val>
            <c:numRef>
              <c:f>VvAPX1!$I$2:$I$7</c:f>
              <c:numCache>
                <c:formatCode>###0.00000;\-###0.00000</c:formatCode>
                <c:ptCount val="6"/>
                <c:pt idx="0">
                  <c:v>1.17210042097789</c:v>
                </c:pt>
                <c:pt idx="1">
                  <c:v>1.5998162159654801</c:v>
                </c:pt>
                <c:pt idx="2">
                  <c:v>1.1838121433656601</c:v>
                </c:pt>
                <c:pt idx="3">
                  <c:v>1.07865130633592</c:v>
                </c:pt>
                <c:pt idx="4">
                  <c:v>0.84241118426068295</c:v>
                </c:pt>
                <c:pt idx="5">
                  <c:v>0.832021353760014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07F-4843-98E0-F5AE4050AB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9"/>
        <c:axId val="217293456"/>
        <c:axId val="217295808"/>
      </c:barChart>
      <c:catAx>
        <c:axId val="217293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7295808"/>
        <c:crosses val="autoZero"/>
        <c:auto val="1"/>
        <c:lblAlgn val="ctr"/>
        <c:lblOffset val="100"/>
        <c:noMultiLvlLbl val="0"/>
      </c:catAx>
      <c:valAx>
        <c:axId val="2172958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Relative expression level</a:t>
                </a:r>
                <a:endParaRPr lang="zh-CN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133803694044782E-2"/>
              <c:y val="0.213026879937475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729345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663672298861971"/>
          <c:y val="0.12603267101252238"/>
          <c:w val="0.14762232356571237"/>
          <c:h val="0.189236657917760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 sz="9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96173"/>
            <a:ext cx="5201841" cy="275734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159854"/>
            <a:ext cx="4589860" cy="1912175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5610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9488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21669"/>
            <a:ext cx="1319585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21669"/>
            <a:ext cx="3882256" cy="671186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4491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7041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974512"/>
            <a:ext cx="5278339" cy="329451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300194"/>
            <a:ext cx="5278339" cy="173250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899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08344"/>
            <a:ext cx="2600921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08344"/>
            <a:ext cx="2600921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4226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21671"/>
            <a:ext cx="5278339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41510"/>
            <a:ext cx="2588967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893014"/>
            <a:ext cx="2588967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41510"/>
            <a:ext cx="2601718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893014"/>
            <a:ext cx="2601718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688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6480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0428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40341"/>
            <a:ext cx="3098155" cy="562836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8022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40341"/>
            <a:ext cx="3098155" cy="562836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8695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21671"/>
            <a:ext cx="5278339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08344"/>
            <a:ext cx="5278339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C92B1-1EF0-48A3-A5A7-193F1A25134F}" type="datetimeFigureOut">
              <a:rPr lang="zh-CN" altLang="en-US" smtClean="0"/>
              <a:t>2023/3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340703"/>
            <a:ext cx="206543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AD125-B481-4CF8-A4BE-40394AC7FF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9374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xmlns="" id="{92F5C899-D3B4-FBB4-CA7D-CB9363A378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3829279"/>
              </p:ext>
            </p:extLst>
          </p:nvPr>
        </p:nvGraphicFramePr>
        <p:xfrm>
          <a:off x="1249451" y="604812"/>
          <a:ext cx="3620909" cy="24515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D2B97E0E-0179-885F-4F6E-B66A1D8CDC22}"/>
              </a:ext>
            </a:extLst>
          </p:cNvPr>
          <p:cNvSpPr txBox="1"/>
          <p:nvPr/>
        </p:nvSpPr>
        <p:spPr>
          <a:xfrm>
            <a:off x="328517" y="3179410"/>
            <a:ext cx="546436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.Transcript 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ttern of </a:t>
            </a:r>
            <a:r>
              <a:rPr lang="en-US" altLang="zh-CN" sz="12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vAPX2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during</a:t>
            </a:r>
            <a:r>
              <a:rPr lang="en-US" altLang="zh-CN" sz="12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. </a:t>
            </a:r>
            <a:r>
              <a:rPr lang="en-US" altLang="zh-CN" sz="1200" b="1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iticola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fection.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leaf discs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tis vinifera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‘Thompson Seedless’ were inoculated with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ticol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s were harvested at 0, 12, 24, 48, 72 and 96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RNA extraction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457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等线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等线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53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79984</dc:creator>
  <cp:lastModifiedBy>MDPI</cp:lastModifiedBy>
  <cp:revision>7</cp:revision>
  <dcterms:created xsi:type="dcterms:W3CDTF">2022-12-18T13:45:22Z</dcterms:created>
  <dcterms:modified xsi:type="dcterms:W3CDTF">2023-03-07T10:58:42Z</dcterms:modified>
</cp:coreProperties>
</file>